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82" r:id="rId2"/>
  </p:sldIdLst>
  <p:sldSz cx="6858000" cy="9906000" type="A4"/>
  <p:notesSz cx="6800850" cy="993298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F00D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  <p:ext uri="{1BD7E111-0CB8-44D6-8891-C1BB2F81B7CC}">
      <p1710:readonlyRecommended xmlns:p1710="http://schemas.microsoft.com/office/powerpoint/2017/10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5381" autoAdjust="0"/>
    <p:restoredTop sz="95865" autoAdjust="0"/>
  </p:normalViewPr>
  <p:slideViewPr>
    <p:cSldViewPr snapToGrid="0">
      <p:cViewPr varScale="1">
        <p:scale>
          <a:sx n="66" d="100"/>
          <a:sy n="66" d="100"/>
        </p:scale>
        <p:origin x="2875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47623" cy="498647"/>
          </a:xfrm>
          <a:prstGeom prst="rect">
            <a:avLst/>
          </a:prstGeom>
        </p:spPr>
        <p:txBody>
          <a:bodyPr vert="horz" lIns="92162" tIns="46081" rIns="92162" bIns="46081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1625" y="0"/>
            <a:ext cx="2947622" cy="498647"/>
          </a:xfrm>
          <a:prstGeom prst="rect">
            <a:avLst/>
          </a:prstGeom>
        </p:spPr>
        <p:txBody>
          <a:bodyPr vert="horz" lIns="92162" tIns="46081" rIns="92162" bIns="46081" rtlCol="0"/>
          <a:lstStyle>
            <a:lvl1pPr algn="r">
              <a:defRPr sz="1200"/>
            </a:lvl1pPr>
          </a:lstStyle>
          <a:p>
            <a:fld id="{D9D91BB7-6D9D-4300-9488-FE6F0B011AF5}" type="datetimeFigureOut">
              <a:rPr kumimoji="1" lang="ja-JP" altLang="en-US" smtClean="0"/>
              <a:t>2025/9/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20925" cy="33512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162" tIns="46081" rIns="92162" bIns="46081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605" y="4780300"/>
            <a:ext cx="5441642" cy="3910864"/>
          </a:xfrm>
          <a:prstGeom prst="rect">
            <a:avLst/>
          </a:prstGeom>
        </p:spPr>
        <p:txBody>
          <a:bodyPr vert="horz" lIns="92162" tIns="46081" rIns="92162" bIns="46081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1" y="9434341"/>
            <a:ext cx="2947623" cy="498647"/>
          </a:xfrm>
          <a:prstGeom prst="rect">
            <a:avLst/>
          </a:prstGeom>
        </p:spPr>
        <p:txBody>
          <a:bodyPr vert="horz" lIns="92162" tIns="46081" rIns="92162" bIns="46081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1625" y="9434341"/>
            <a:ext cx="2947622" cy="498647"/>
          </a:xfrm>
          <a:prstGeom prst="rect">
            <a:avLst/>
          </a:prstGeom>
        </p:spPr>
        <p:txBody>
          <a:bodyPr vert="horz" lIns="92162" tIns="46081" rIns="92162" bIns="46081" rtlCol="0" anchor="b"/>
          <a:lstStyle>
            <a:lvl1pPr algn="r">
              <a:defRPr sz="1200"/>
            </a:lvl1pPr>
          </a:lstStyle>
          <a:p>
            <a:fld id="{1454848C-FEA4-4A2B-87C2-C604F6929D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65039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120F0-1B69-4C06-880B-C0DF36F697EE}" type="datetimeFigureOut">
              <a:rPr kumimoji="1" lang="ja-JP" altLang="en-US" smtClean="0"/>
              <a:t>2025/9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26F40-02E4-4AD1-B00C-B67344B9AA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39865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120F0-1B69-4C06-880B-C0DF36F697EE}" type="datetimeFigureOut">
              <a:rPr kumimoji="1" lang="ja-JP" altLang="en-US" smtClean="0"/>
              <a:t>2025/9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26F40-02E4-4AD1-B00C-B67344B9AA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09747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120F0-1B69-4C06-880B-C0DF36F697EE}" type="datetimeFigureOut">
              <a:rPr kumimoji="1" lang="ja-JP" altLang="en-US" smtClean="0"/>
              <a:t>2025/9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26F40-02E4-4AD1-B00C-B67344B9AA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21689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120F0-1B69-4C06-880B-C0DF36F697EE}" type="datetimeFigureOut">
              <a:rPr kumimoji="1" lang="ja-JP" altLang="en-US" smtClean="0"/>
              <a:t>2025/9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26F40-02E4-4AD1-B00C-B67344B9AA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047384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120F0-1B69-4C06-880B-C0DF36F697EE}" type="datetimeFigureOut">
              <a:rPr kumimoji="1" lang="ja-JP" altLang="en-US" smtClean="0"/>
              <a:t>2025/9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26F40-02E4-4AD1-B00C-B67344B9AA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12066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120F0-1B69-4C06-880B-C0DF36F697EE}" type="datetimeFigureOut">
              <a:rPr kumimoji="1" lang="ja-JP" altLang="en-US" smtClean="0"/>
              <a:t>2025/9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26F40-02E4-4AD1-B00C-B67344B9AA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44366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120F0-1B69-4C06-880B-C0DF36F697EE}" type="datetimeFigureOut">
              <a:rPr kumimoji="1" lang="ja-JP" altLang="en-US" smtClean="0"/>
              <a:t>2025/9/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26F40-02E4-4AD1-B00C-B67344B9AA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68680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120F0-1B69-4C06-880B-C0DF36F697EE}" type="datetimeFigureOut">
              <a:rPr kumimoji="1" lang="ja-JP" altLang="en-US" smtClean="0"/>
              <a:t>2025/9/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26F40-02E4-4AD1-B00C-B67344B9AA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039160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120F0-1B69-4C06-880B-C0DF36F697EE}" type="datetimeFigureOut">
              <a:rPr kumimoji="1" lang="ja-JP" altLang="en-US" smtClean="0"/>
              <a:t>2025/9/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26F40-02E4-4AD1-B00C-B67344B9AA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24212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120F0-1B69-4C06-880B-C0DF36F697EE}" type="datetimeFigureOut">
              <a:rPr kumimoji="1" lang="ja-JP" altLang="en-US" smtClean="0"/>
              <a:t>2025/9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26F40-02E4-4AD1-B00C-B67344B9AA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88540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120F0-1B69-4C06-880B-C0DF36F697EE}" type="datetimeFigureOut">
              <a:rPr kumimoji="1" lang="ja-JP" altLang="en-US" smtClean="0"/>
              <a:t>2025/9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26F40-02E4-4AD1-B00C-B67344B9AA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34375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3120F0-1B69-4C06-880B-C0DF36F697EE}" type="datetimeFigureOut">
              <a:rPr kumimoji="1" lang="ja-JP" altLang="en-US" smtClean="0"/>
              <a:t>2025/9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726F40-02E4-4AD1-B00C-B67344B9AA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45018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DC0496D-37C2-B770-4CD3-7C384CB372B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20065F35-71D9-61B6-122B-FB0FE42891F8}"/>
              </a:ext>
            </a:extLst>
          </p:cNvPr>
          <p:cNvSpPr txBox="1"/>
          <p:nvPr/>
        </p:nvSpPr>
        <p:spPr>
          <a:xfrm>
            <a:off x="3297904" y="64583"/>
            <a:ext cx="388521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kumimoji="1" lang="ja-JP" alt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Table 2</a:t>
            </a:r>
            <a:endParaRPr kumimoji="1" lang="ja-JP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CD66A8DD-2136-2E86-1534-A88E003CB99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88613635"/>
              </p:ext>
            </p:extLst>
          </p:nvPr>
        </p:nvGraphicFramePr>
        <p:xfrm>
          <a:off x="172719" y="812345"/>
          <a:ext cx="6512561" cy="1903279"/>
        </p:xfrm>
        <a:graphic>
          <a:graphicData uri="http://schemas.openxmlformats.org/drawingml/2006/table">
            <a:tbl>
              <a:tblPr/>
              <a:tblGrid>
                <a:gridCol w="1610360">
                  <a:extLst>
                    <a:ext uri="{9D8B030D-6E8A-4147-A177-3AD203B41FA5}">
                      <a16:colId xmlns:a16="http://schemas.microsoft.com/office/drawing/2014/main" val="808270635"/>
                    </a:ext>
                  </a:extLst>
                </a:gridCol>
                <a:gridCol w="1078312">
                  <a:extLst>
                    <a:ext uri="{9D8B030D-6E8A-4147-A177-3AD203B41FA5}">
                      <a16:colId xmlns:a16="http://schemas.microsoft.com/office/drawing/2014/main" val="1589273949"/>
                    </a:ext>
                  </a:extLst>
                </a:gridCol>
                <a:gridCol w="816559">
                  <a:extLst>
                    <a:ext uri="{9D8B030D-6E8A-4147-A177-3AD203B41FA5}">
                      <a16:colId xmlns:a16="http://schemas.microsoft.com/office/drawing/2014/main" val="3411872730"/>
                    </a:ext>
                  </a:extLst>
                </a:gridCol>
                <a:gridCol w="428196">
                  <a:extLst>
                    <a:ext uri="{9D8B030D-6E8A-4147-A177-3AD203B41FA5}">
                      <a16:colId xmlns:a16="http://schemas.microsoft.com/office/drawing/2014/main" val="2527111622"/>
                    </a:ext>
                  </a:extLst>
                </a:gridCol>
                <a:gridCol w="278826">
                  <a:extLst>
                    <a:ext uri="{9D8B030D-6E8A-4147-A177-3AD203B41FA5}">
                      <a16:colId xmlns:a16="http://schemas.microsoft.com/office/drawing/2014/main" val="744047248"/>
                    </a:ext>
                  </a:extLst>
                </a:gridCol>
                <a:gridCol w="995804">
                  <a:extLst>
                    <a:ext uri="{9D8B030D-6E8A-4147-A177-3AD203B41FA5}">
                      <a16:colId xmlns:a16="http://schemas.microsoft.com/office/drawing/2014/main" val="1303051549"/>
                    </a:ext>
                  </a:extLst>
                </a:gridCol>
                <a:gridCol w="876308">
                  <a:extLst>
                    <a:ext uri="{9D8B030D-6E8A-4147-A177-3AD203B41FA5}">
                      <a16:colId xmlns:a16="http://schemas.microsoft.com/office/drawing/2014/main" val="3194175486"/>
                    </a:ext>
                  </a:extLst>
                </a:gridCol>
                <a:gridCol w="428196">
                  <a:extLst>
                    <a:ext uri="{9D8B030D-6E8A-4147-A177-3AD203B41FA5}">
                      <a16:colId xmlns:a16="http://schemas.microsoft.com/office/drawing/2014/main" val="245467934"/>
                    </a:ext>
                  </a:extLst>
                </a:gridCol>
              </a:tblGrid>
              <a:tr h="162799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5427" marR="5427" marT="54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male</a:t>
                      </a:r>
                    </a:p>
                  </a:txBody>
                  <a:tcPr marL="5427" marR="5427" marT="54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5427" marR="5427" marT="54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female</a:t>
                      </a:r>
                    </a:p>
                  </a:txBody>
                  <a:tcPr marL="5427" marR="5427" marT="54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78678283"/>
                  </a:ext>
                </a:extLst>
              </a:tr>
              <a:tr h="162799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ja-JP" alt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5427" marR="5427" marT="54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Young</a:t>
                      </a:r>
                    </a:p>
                  </a:txBody>
                  <a:tcPr marL="5427" marR="5427" marT="54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ged</a:t>
                      </a:r>
                    </a:p>
                  </a:txBody>
                  <a:tcPr marL="5427" marR="5427" marT="54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p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value </a:t>
                      </a:r>
                    </a:p>
                  </a:txBody>
                  <a:tcPr marL="5427" marR="5427" marT="54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5427" marR="5427" marT="54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Young </a:t>
                      </a:r>
                    </a:p>
                  </a:txBody>
                  <a:tcPr marL="5427" marR="5427" marT="54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ged</a:t>
                      </a:r>
                    </a:p>
                  </a:txBody>
                  <a:tcPr marL="5427" marR="5427" marT="54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p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value </a:t>
                      </a:r>
                    </a:p>
                  </a:txBody>
                  <a:tcPr marL="5427" marR="5427" marT="54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45889120"/>
                  </a:ext>
                </a:extLst>
              </a:tr>
              <a:tr h="374437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Vascular Endothelial NAD</a:t>
                      </a:r>
                      <a:r>
                        <a:rPr lang="en-US" altLang="ja-JP" sz="8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+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ＭＳ Ｐゴシック" panose="020B0600070205080204" pitchFamily="50" charset="-128"/>
                          <a:ea typeface="ＭＳ Ｐゴシック" panose="020B0600070205080204" pitchFamily="50" charset="-128"/>
                        </a:rPr>
                        <a:t>　　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(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pmole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/mg wet cells)</a:t>
                      </a:r>
                    </a:p>
                  </a:txBody>
                  <a:tcPr marL="5427" marR="5427" marT="54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37.99 ± 6.12</a:t>
                      </a:r>
                      <a:b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(</a:t>
                      </a:r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= 4)</a:t>
                      </a:r>
                    </a:p>
                  </a:txBody>
                  <a:tcPr marL="5427" marR="5427" marT="54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7.76 ± 5.56</a:t>
                      </a:r>
                      <a:b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(</a:t>
                      </a:r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= 4)</a:t>
                      </a:r>
                    </a:p>
                  </a:txBody>
                  <a:tcPr marL="5427" marR="5427" marT="54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0499</a:t>
                      </a:r>
                      <a:r>
                        <a:rPr lang="en-US" altLang="ja-JP" sz="80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*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427" marR="5427" marT="54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5427" marR="5427" marT="54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38.47 ± 2.14</a:t>
                      </a:r>
                      <a:b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(</a:t>
                      </a:r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= 7)</a:t>
                      </a:r>
                    </a:p>
                  </a:txBody>
                  <a:tcPr marL="5427" marR="5427" marT="54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31.51 ± 1.39</a:t>
                      </a:r>
                      <a:b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(</a:t>
                      </a:r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= 4)</a:t>
                      </a:r>
                    </a:p>
                  </a:txBody>
                  <a:tcPr marL="5427" marR="5427" marT="54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0495</a:t>
                      </a:r>
                      <a:r>
                        <a:rPr lang="en-US" altLang="ja-JP" sz="80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*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427" marR="5427" marT="54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94772688"/>
                  </a:ext>
                </a:extLst>
              </a:tr>
              <a:tr h="255052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SBP (mmHg)</a:t>
                      </a:r>
                    </a:p>
                  </a:txBody>
                  <a:tcPr marL="5427" marR="5427" marT="54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13.0 ± 5.1</a:t>
                      </a:r>
                      <a:b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(</a:t>
                      </a:r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= 5)</a:t>
                      </a:r>
                    </a:p>
                  </a:txBody>
                  <a:tcPr marL="5427" marR="5427" marT="54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30.0 ± 4.8</a:t>
                      </a:r>
                      <a:b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(</a:t>
                      </a:r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= 6)</a:t>
                      </a:r>
                    </a:p>
                  </a:txBody>
                  <a:tcPr marL="5427" marR="5427" marT="54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0387</a:t>
                      </a:r>
                      <a:r>
                        <a:rPr lang="en-US" altLang="ja-JP" sz="80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*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427" marR="5427" marT="54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5427" marR="5427" marT="54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15.3 ± 4.3</a:t>
                      </a:r>
                      <a:b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(</a:t>
                      </a:r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= 10)</a:t>
                      </a:r>
                    </a:p>
                  </a:txBody>
                  <a:tcPr marL="5427" marR="5427" marT="54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26.3 ± 4.9</a:t>
                      </a:r>
                      <a:b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(</a:t>
                      </a:r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= 8)</a:t>
                      </a:r>
                    </a:p>
                  </a:txBody>
                  <a:tcPr marL="5427" marR="5427" marT="54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109</a:t>
                      </a:r>
                    </a:p>
                  </a:txBody>
                  <a:tcPr marL="5427" marR="5427" marT="54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97731081"/>
                  </a:ext>
                </a:extLst>
              </a:tr>
              <a:tr h="255052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DBP (mmHg)</a:t>
                      </a:r>
                    </a:p>
                  </a:txBody>
                  <a:tcPr marL="5427" marR="5427" marT="54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60.33 ± 5.41</a:t>
                      </a:r>
                      <a:b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(</a:t>
                      </a:r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= 5)</a:t>
                      </a:r>
                    </a:p>
                  </a:txBody>
                  <a:tcPr marL="5427" marR="5427" marT="54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77.27 ± 4.70</a:t>
                      </a:r>
                      <a:b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(</a:t>
                      </a:r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= 6)</a:t>
                      </a:r>
                    </a:p>
                  </a:txBody>
                  <a:tcPr marL="5427" marR="5427" marT="54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0416</a:t>
                      </a:r>
                      <a:r>
                        <a:rPr lang="en-US" altLang="ja-JP" sz="80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*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427" marR="5427" marT="54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5427" marR="5427" marT="54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64.79 ± 5.91</a:t>
                      </a:r>
                      <a:b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(</a:t>
                      </a:r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= 10)</a:t>
                      </a:r>
                    </a:p>
                  </a:txBody>
                  <a:tcPr marL="5427" marR="5427" marT="54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76.57 ± 3.34</a:t>
                      </a:r>
                      <a:b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(</a:t>
                      </a:r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= 8)</a:t>
                      </a:r>
                    </a:p>
                  </a:txBody>
                  <a:tcPr marL="5427" marR="5427" marT="54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125</a:t>
                      </a:r>
                    </a:p>
                  </a:txBody>
                  <a:tcPr marL="5427" marR="5427" marT="54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31341735"/>
                  </a:ext>
                </a:extLst>
              </a:tr>
              <a:tr h="329556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ardia mass    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ＭＳ Ｐゴシック" panose="020B0600070205080204" pitchFamily="50" charset="-128"/>
                          <a:ea typeface="ＭＳ Ｐゴシック" panose="020B0600070205080204" pitchFamily="50" charset="-128"/>
                        </a:rPr>
                        <a:t>　　　　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            (mg/g-body weight)</a:t>
                      </a:r>
                    </a:p>
                  </a:txBody>
                  <a:tcPr marL="5427" marR="5427" marT="54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4.915 ± 0.061</a:t>
                      </a:r>
                      <a:b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(</a:t>
                      </a:r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= 10)</a:t>
                      </a:r>
                    </a:p>
                  </a:txBody>
                  <a:tcPr marL="5427" marR="5427" marT="54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5.847 ± 0.303</a:t>
                      </a:r>
                      <a:b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(</a:t>
                      </a:r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= 5)</a:t>
                      </a:r>
                    </a:p>
                  </a:txBody>
                  <a:tcPr marL="5427" marR="5427" marT="54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&lt;0.01</a:t>
                      </a:r>
                      <a:r>
                        <a:rPr lang="en-US" altLang="ja-JP" sz="80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**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427" marR="5427" marT="54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5427" marR="5427" marT="54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4.925 ± 0.088</a:t>
                      </a:r>
                      <a:b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(</a:t>
                      </a:r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= 6)</a:t>
                      </a:r>
                    </a:p>
                  </a:txBody>
                  <a:tcPr marL="5427" marR="5427" marT="54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4.773 ± 0.055</a:t>
                      </a:r>
                      <a:b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(</a:t>
                      </a:r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= 4)</a:t>
                      </a:r>
                    </a:p>
                  </a:txBody>
                  <a:tcPr marL="5427" marR="5427" marT="54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235</a:t>
                      </a:r>
                    </a:p>
                  </a:txBody>
                  <a:tcPr marL="5427" marR="5427" marT="54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85401659"/>
                  </a:ext>
                </a:extLst>
              </a:tr>
              <a:tr h="36358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Media thickness/ Lumen diameter</a:t>
                      </a:r>
                    </a:p>
                  </a:txBody>
                  <a:tcPr marL="5427" marR="5427" marT="54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08638 ± 0.00900</a:t>
                      </a:r>
                      <a:b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(</a:t>
                      </a:r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= 5)</a:t>
                      </a:r>
                    </a:p>
                  </a:txBody>
                  <a:tcPr marL="5427" marR="5427" marT="54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1218 ± 0.0028</a:t>
                      </a:r>
                      <a:b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(</a:t>
                      </a:r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= 4)</a:t>
                      </a:r>
                    </a:p>
                  </a:txBody>
                  <a:tcPr marL="5427" marR="5427" marT="54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0118</a:t>
                      </a:r>
                      <a:r>
                        <a:rPr lang="en-US" altLang="ja-JP" sz="80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*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427" marR="5427" marT="54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5427" marR="5427" marT="54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09248 ± 0.00442</a:t>
                      </a:r>
                      <a:b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(</a:t>
                      </a:r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= 5)</a:t>
                      </a:r>
                    </a:p>
                  </a:txBody>
                  <a:tcPr marL="5427" marR="5427" marT="54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1050 ± 0.0062</a:t>
                      </a:r>
                      <a:b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(</a:t>
                      </a:r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= 5)</a:t>
                      </a:r>
                    </a:p>
                  </a:txBody>
                  <a:tcPr marL="5427" marR="5427" marT="54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138</a:t>
                      </a:r>
                    </a:p>
                  </a:txBody>
                  <a:tcPr marL="5427" marR="5427" marT="54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90618871"/>
                  </a:ext>
                </a:extLst>
              </a:tr>
            </a:tbl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AD173B2F-65EA-51E3-F07C-C0438EA835BF}"/>
              </a:ext>
            </a:extLst>
          </p:cNvPr>
          <p:cNvSpPr txBox="1"/>
          <p:nvPr/>
        </p:nvSpPr>
        <p:spPr>
          <a:xfrm>
            <a:off x="261620" y="2786277"/>
            <a:ext cx="665734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80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BP; </a:t>
            </a:r>
            <a:r>
              <a:rPr lang="en-US" altLang="ja-JP" sz="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ystolic </a:t>
            </a:r>
            <a:r>
              <a:rPr lang="en-US" altLang="ja-JP" sz="80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blood pressure, DBP; </a:t>
            </a:r>
            <a:r>
              <a:rPr lang="en-US" altLang="ja-JP" sz="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diastolic blood pressure</a:t>
            </a:r>
            <a:r>
              <a:rPr lang="en-US" altLang="ja-JP" sz="80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.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80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Data were analyzed using Student’s unpaired </a:t>
            </a:r>
            <a:r>
              <a:rPr lang="en-US" altLang="ja-JP" sz="800" i="1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t</a:t>
            </a:r>
            <a:r>
              <a:rPr lang="en-US" altLang="ja-JP" sz="80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-test. All values are presented as the mean ± SEM. </a:t>
            </a:r>
            <a:r>
              <a:rPr kumimoji="0" lang="en-US" altLang="ja-JP" sz="800" b="0" i="1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*p &lt; </a:t>
            </a:r>
            <a:r>
              <a:rPr kumimoji="0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0.05</a:t>
            </a:r>
            <a:r>
              <a:rPr kumimoji="0" lang="en-US" altLang="ja-JP" sz="800" b="0" i="1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, </a:t>
            </a:r>
            <a:r>
              <a:rPr kumimoji="0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**</a:t>
            </a:r>
            <a:r>
              <a:rPr kumimoji="0" lang="en-US" altLang="ja-JP" sz="800" b="0" i="1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p </a:t>
            </a:r>
            <a:r>
              <a:rPr kumimoji="0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&lt; 0.01.</a:t>
            </a:r>
          </a:p>
          <a:p>
            <a:endParaRPr lang="en-US" altLang="ja-JP" sz="800" dirty="0">
              <a:solidFill>
                <a:srgbClr val="000000"/>
              </a:solidFill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859073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56</TotalTime>
  <Words>291</Words>
  <Application>Microsoft Office PowerPoint</Application>
  <PresentationFormat>A4 210 x 297 mm</PresentationFormat>
  <Paragraphs>5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ＭＳ Ｐゴシック</vt:lpstr>
      <vt:lpstr>游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 Y</dc:creator>
  <cp:lastModifiedBy>yama1005@keio.jp</cp:lastModifiedBy>
  <cp:revision>511</cp:revision>
  <cp:lastPrinted>2025-08-07T09:30:53Z</cp:lastPrinted>
  <dcterms:created xsi:type="dcterms:W3CDTF">2020-05-07T06:16:48Z</dcterms:created>
  <dcterms:modified xsi:type="dcterms:W3CDTF">2025-09-05T14:08:16Z</dcterms:modified>
</cp:coreProperties>
</file>